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88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9E73"/>
    <a:srgbClr val="BFBFBF"/>
    <a:srgbClr val="8D8DFF"/>
    <a:srgbClr val="4FB6E9"/>
    <a:srgbClr val="9001D4"/>
    <a:srgbClr val="019E73"/>
    <a:srgbClr val="000080"/>
    <a:srgbClr val="C8D1E2"/>
    <a:srgbClr val="FFFFFF"/>
    <a:srgbClr val="90BFF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–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F2DE63D5-997A-4646-A377-4702673A728D}" styleName="Light Style 2 – Accent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69C7853C-536D-4A76-A0AE-DD22124D55A5}" styleName="Themed Style 1 – Accent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473" autoAdjust="0"/>
    <p:restoredTop sz="94384" autoAdjust="0"/>
  </p:normalViewPr>
  <p:slideViewPr>
    <p:cSldViewPr snapToGrid="0">
      <p:cViewPr varScale="1">
        <p:scale>
          <a:sx n="84" d="100"/>
          <a:sy n="84" d="100"/>
        </p:scale>
        <p:origin x="3848" y="184"/>
      </p:cViewPr>
      <p:guideLst/>
    </p:cSldViewPr>
  </p:slideViewPr>
  <p:notesTextViewPr>
    <p:cViewPr>
      <p:scale>
        <a:sx n="75" d="100"/>
        <a:sy n="75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E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E63D69F-7222-B14D-9E01-39F81D144C7F}" type="datetimeFigureOut">
              <a:rPr lang="en-ES" smtClean="0"/>
              <a:t>18/6/25</a:t>
            </a:fld>
            <a:endParaRPr lang="en-E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E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AE3D8AD-4781-4F42-A424-48FC4D64EB44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10763265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AE3D8AD-4781-4F42-A424-48FC4D64EB44}" type="slidenum">
              <a:rPr lang="en-ES" smtClean="0"/>
              <a:t>1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152820396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4440C-1931-844E-8E1C-5C48591A4CD4}" type="datetimeFigureOut">
              <a:rPr lang="en-ES" smtClean="0"/>
              <a:t>18/6/25</a:t>
            </a:fld>
            <a:endParaRPr lang="en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E7698-6084-F64E-B258-69D5634F729E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21768171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4440C-1931-844E-8E1C-5C48591A4CD4}" type="datetimeFigureOut">
              <a:rPr lang="en-ES" smtClean="0"/>
              <a:t>18/6/25</a:t>
            </a:fld>
            <a:endParaRPr lang="en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E7698-6084-F64E-B258-69D5634F729E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11828919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4440C-1931-844E-8E1C-5C48591A4CD4}" type="datetimeFigureOut">
              <a:rPr lang="en-ES" smtClean="0"/>
              <a:t>18/6/25</a:t>
            </a:fld>
            <a:endParaRPr lang="en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E7698-6084-F64E-B258-69D5634F729E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9334202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4440C-1931-844E-8E1C-5C48591A4CD4}" type="datetimeFigureOut">
              <a:rPr lang="en-ES" smtClean="0"/>
              <a:t>18/6/25</a:t>
            </a:fld>
            <a:endParaRPr lang="en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E7698-6084-F64E-B258-69D5634F729E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25013514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4440C-1931-844E-8E1C-5C48591A4CD4}" type="datetimeFigureOut">
              <a:rPr lang="en-ES" smtClean="0"/>
              <a:t>18/6/25</a:t>
            </a:fld>
            <a:endParaRPr lang="en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E7698-6084-F64E-B258-69D5634F729E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19816048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4440C-1931-844E-8E1C-5C48591A4CD4}" type="datetimeFigureOut">
              <a:rPr lang="en-ES" smtClean="0"/>
              <a:t>18/6/25</a:t>
            </a:fld>
            <a:endParaRPr lang="en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E7698-6084-F64E-B258-69D5634F729E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27941971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4440C-1931-844E-8E1C-5C48591A4CD4}" type="datetimeFigureOut">
              <a:rPr lang="en-ES" smtClean="0"/>
              <a:t>18/6/25</a:t>
            </a:fld>
            <a:endParaRPr lang="en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E7698-6084-F64E-B258-69D5634F729E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14312474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4440C-1931-844E-8E1C-5C48591A4CD4}" type="datetimeFigureOut">
              <a:rPr lang="en-ES" smtClean="0"/>
              <a:t>18/6/25</a:t>
            </a:fld>
            <a:endParaRPr lang="en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E7698-6084-F64E-B258-69D5634F729E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14729429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4440C-1931-844E-8E1C-5C48591A4CD4}" type="datetimeFigureOut">
              <a:rPr lang="en-ES" smtClean="0"/>
              <a:t>18/6/25</a:t>
            </a:fld>
            <a:endParaRPr lang="en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E7698-6084-F64E-B258-69D5634F729E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15838796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4440C-1931-844E-8E1C-5C48591A4CD4}" type="datetimeFigureOut">
              <a:rPr lang="en-ES" smtClean="0"/>
              <a:t>18/6/25</a:t>
            </a:fld>
            <a:endParaRPr lang="en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E7698-6084-F64E-B258-69D5634F729E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24174889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 dirty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4440C-1931-844E-8E1C-5C48591A4CD4}" type="datetimeFigureOut">
              <a:rPr lang="en-ES" smtClean="0"/>
              <a:t>18/6/25</a:t>
            </a:fld>
            <a:endParaRPr lang="en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E7698-6084-F64E-B258-69D5634F729E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26339171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44440C-1931-844E-8E1C-5C48591A4CD4}" type="datetimeFigureOut">
              <a:rPr lang="en-ES" smtClean="0"/>
              <a:t>18/6/25</a:t>
            </a:fld>
            <a:endParaRPr lang="en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2E7698-6084-F64E-B258-69D5634F729E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20743689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52EC90E5-F240-2750-5581-3A2DD329F5E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602660"/>
              </p:ext>
            </p:extLst>
          </p:nvPr>
        </p:nvGraphicFramePr>
        <p:xfrm>
          <a:off x="1150750" y="1064700"/>
          <a:ext cx="4556500" cy="66751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054938">
                  <a:extLst>
                    <a:ext uri="{9D8B030D-6E8A-4147-A177-3AD203B41FA5}">
                      <a16:colId xmlns:a16="http://schemas.microsoft.com/office/drawing/2014/main" val="2761832959"/>
                    </a:ext>
                  </a:extLst>
                </a:gridCol>
                <a:gridCol w="189477">
                  <a:extLst>
                    <a:ext uri="{9D8B030D-6E8A-4147-A177-3AD203B41FA5}">
                      <a16:colId xmlns:a16="http://schemas.microsoft.com/office/drawing/2014/main" val="2708621317"/>
                    </a:ext>
                  </a:extLst>
                </a:gridCol>
                <a:gridCol w="2312085">
                  <a:extLst>
                    <a:ext uri="{9D8B030D-6E8A-4147-A177-3AD203B41FA5}">
                      <a16:colId xmlns:a16="http://schemas.microsoft.com/office/drawing/2014/main" val="3809745514"/>
                    </a:ext>
                  </a:extLst>
                </a:gridCol>
              </a:tblGrid>
              <a:tr h="440463">
                <a:tc gridSpan="3">
                  <a:txBody>
                    <a:bodyPr/>
                    <a:lstStyle/>
                    <a:p>
                      <a:r>
                        <a:rPr lang="en-GB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4 Table — SEC-SAXS data collection and derived parameters for IgAse1–7.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 hMerge="1">
                  <a:txBody>
                    <a:bodyPr/>
                    <a:lstStyle/>
                    <a:p>
                      <a:endParaRPr lang="en-GB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76772406"/>
                  </a:ext>
                </a:extLst>
              </a:tr>
              <a:tr h="249711">
                <a:tc gridSpan="3">
                  <a:txBody>
                    <a:bodyPr/>
                    <a:lstStyle/>
                    <a:p>
                      <a:r>
                        <a:rPr lang="en-GB" sz="11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strumentatio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 hMerge="1">
                  <a:txBody>
                    <a:bodyPr/>
                    <a:lstStyle/>
                    <a:p>
                      <a:endParaRPr lang="en-GB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048920"/>
                  </a:ext>
                </a:extLst>
              </a:tr>
              <a:tr h="249711">
                <a:tc>
                  <a:txBody>
                    <a:bodyPr/>
                    <a:lstStyle/>
                    <a:p>
                      <a:r>
                        <a:rPr lang="en-GB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eamlin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M-29 (ESRF)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GB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30955823"/>
                  </a:ext>
                </a:extLst>
              </a:tr>
              <a:tr h="249711">
                <a:tc>
                  <a:txBody>
                    <a:bodyPr/>
                    <a:lstStyle/>
                    <a:p>
                      <a:r>
                        <a:rPr lang="en-GB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eam geometry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int-collimated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GB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10395192"/>
                  </a:ext>
                </a:extLst>
              </a:tr>
              <a:tr h="249711">
                <a:tc>
                  <a:txBody>
                    <a:bodyPr/>
                    <a:lstStyle/>
                    <a:p>
                      <a:r>
                        <a:rPr lang="en-GB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tector / wavelength (nm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ilatus3 2M (</a:t>
                      </a:r>
                      <a:r>
                        <a:rPr lang="en-GB" sz="11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ctris</a:t>
                      </a:r>
                      <a:r>
                        <a:rPr lang="en-GB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 in vacuum / 0.99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GB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20844582"/>
                  </a:ext>
                </a:extLst>
              </a:tr>
              <a:tr h="249711">
                <a:tc>
                  <a:txBody>
                    <a:bodyPr/>
                    <a:lstStyle/>
                    <a:p>
                      <a:r>
                        <a:rPr lang="en-GB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mple-to-detector distance (m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867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GB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38770229"/>
                  </a:ext>
                </a:extLst>
              </a:tr>
              <a:tr h="249711">
                <a:tc>
                  <a:txBody>
                    <a:bodyPr/>
                    <a:lstStyle/>
                    <a:p>
                      <a:r>
                        <a:rPr lang="en-GB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posure time (s) / frame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 / 250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GB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58555343"/>
                  </a:ext>
                </a:extLst>
              </a:tr>
              <a:tr h="249711">
                <a:tc>
                  <a:txBody>
                    <a:bodyPr/>
                    <a:lstStyle/>
                    <a:p>
                      <a:r>
                        <a:rPr lang="en-GB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sured </a:t>
                      </a:r>
                      <a:r>
                        <a:rPr lang="en-GB" sz="11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</a:t>
                      </a:r>
                      <a:r>
                        <a:rPr lang="en-GB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range (nm</a:t>
                      </a:r>
                      <a:r>
                        <a:rPr lang="en-GB" sz="11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</a:t>
                      </a:r>
                      <a:r>
                        <a:rPr lang="en-GB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7–0.500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GB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36825637"/>
                  </a:ext>
                </a:extLst>
              </a:tr>
              <a:tr h="249711">
                <a:tc>
                  <a:txBody>
                    <a:bodyPr/>
                    <a:lstStyle/>
                    <a:p>
                      <a:r>
                        <a:rPr lang="en-GB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C chromatography colum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 err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uperose</a:t>
                      </a: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6 Increase 5/150 GL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31271065"/>
                  </a:ext>
                </a:extLst>
              </a:tr>
              <a:tr h="249711">
                <a:tc>
                  <a:txBody>
                    <a:bodyPr/>
                    <a:lstStyle/>
                    <a:p>
                      <a:r>
                        <a:rPr lang="en-GB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low rate (mL min</a:t>
                      </a:r>
                      <a:r>
                        <a:rPr lang="en-GB" sz="11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</a:t>
                      </a:r>
                      <a:r>
                        <a:rPr lang="en-GB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78515510"/>
                  </a:ext>
                </a:extLst>
              </a:tr>
              <a:tr h="249711">
                <a:tc>
                  <a:txBody>
                    <a:bodyPr/>
                    <a:lstStyle/>
                    <a:p>
                      <a:r>
                        <a:rPr lang="en-GB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emperature (K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3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GB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58682883"/>
                  </a:ext>
                </a:extLst>
              </a:tr>
              <a:tr h="249711">
                <a:tc gridSpan="3">
                  <a:txBody>
                    <a:bodyPr/>
                    <a:lstStyle/>
                    <a:p>
                      <a:r>
                        <a:rPr lang="en-GB" sz="11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ftwar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lang="en-GB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9484647"/>
                  </a:ext>
                </a:extLst>
              </a:tr>
              <a:tr h="249711">
                <a:tc>
                  <a:txBody>
                    <a:bodyPr/>
                    <a:lstStyle/>
                    <a:p>
                      <a:r>
                        <a:rPr lang="en-GB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ata reduction / processing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11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reeSAS</a:t>
                      </a:r>
                      <a:r>
                        <a:rPr lang="en-GB" sz="11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/ </a:t>
                      </a:r>
                      <a:r>
                        <a:rPr lang="en-GB" sz="11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romixs</a:t>
                      </a:r>
                      <a:endParaRPr lang="en-GB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GB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81072976"/>
                  </a:ext>
                </a:extLst>
              </a:tr>
              <a:tr h="249711">
                <a:tc>
                  <a:txBody>
                    <a:bodyPr/>
                    <a:lstStyle/>
                    <a:p>
                      <a:r>
                        <a:rPr lang="en-GB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uinier /IFT analysi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XTAS</a:t>
                      </a:r>
                      <a:r>
                        <a:rPr lang="en-GB" sz="11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Raw /</a:t>
                      </a:r>
                      <a:r>
                        <a:rPr lang="en-GB" sz="11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XTAS</a:t>
                      </a:r>
                      <a:r>
                        <a:rPr lang="en-GB" sz="11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Raw (</a:t>
                      </a:r>
                      <a:r>
                        <a:rPr lang="en-GB" sz="11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nom</a:t>
                      </a:r>
                      <a:r>
                        <a:rPr lang="en-GB" sz="11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en-GB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52925710"/>
                  </a:ext>
                </a:extLst>
              </a:tr>
              <a:tr h="249711">
                <a:tc>
                  <a:txBody>
                    <a:bodyPr/>
                    <a:lstStyle/>
                    <a:p>
                      <a:r>
                        <a:rPr lang="en-GB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nsemble generation and fitting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11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om</a:t>
                      </a:r>
                      <a:endParaRPr lang="en-GB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GB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11843940"/>
                  </a:ext>
                </a:extLst>
              </a:tr>
              <a:tr h="249711">
                <a:tc>
                  <a:txBody>
                    <a:bodyPr/>
                    <a:lstStyle/>
                    <a:p>
                      <a:r>
                        <a:rPr lang="en-GB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aphic representatio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11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yMOL</a:t>
                      </a:r>
                      <a:endParaRPr lang="en-GB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GB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81917586"/>
                  </a:ext>
                </a:extLst>
              </a:tr>
              <a:tr h="249711">
                <a:tc gridSpan="3">
                  <a:txBody>
                    <a:bodyPr/>
                    <a:lstStyle/>
                    <a:p>
                      <a:r>
                        <a:rPr lang="en-GB" sz="11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ata collection and derived parameter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262845637"/>
                  </a:ext>
                </a:extLst>
              </a:tr>
              <a:tr h="249711">
                <a:tc gridSpan="2">
                  <a:txBody>
                    <a:bodyPr/>
                    <a:lstStyle/>
                    <a:p>
                      <a:r>
                        <a:rPr lang="en-GB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mple concentration (mg mL</a:t>
                      </a:r>
                      <a:r>
                        <a:rPr lang="en-GB" sz="11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</a:t>
                      </a:r>
                      <a:r>
                        <a:rPr lang="en-GB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GB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91852660"/>
                  </a:ext>
                </a:extLst>
              </a:tr>
              <a:tr h="249711">
                <a:tc gridSpan="2">
                  <a:txBody>
                    <a:bodyPr/>
                    <a:lstStyle/>
                    <a:p>
                      <a:r>
                        <a:rPr lang="en-GB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rames/</a:t>
                      </a:r>
                      <a:r>
                        <a:rPr lang="en-GB" sz="11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min</a:t>
                      </a:r>
                      <a:r>
                        <a:rPr lang="en-GB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nm</a:t>
                      </a:r>
                      <a:r>
                        <a:rPr lang="en-GB" sz="11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</a:t>
                      </a:r>
                      <a:r>
                        <a:rPr lang="en-GB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/</a:t>
                      </a:r>
                      <a:r>
                        <a:rPr lang="en-GB" sz="11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max</a:t>
                      </a:r>
                      <a:r>
                        <a:rPr lang="en-GB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nm</a:t>
                      </a:r>
                      <a:r>
                        <a:rPr lang="en-GB" sz="11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</a:t>
                      </a:r>
                      <a:r>
                        <a:rPr lang="en-GB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–475 / 0.0866 / 2.504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–475 / 0.0866 / 2.5049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01667327"/>
                  </a:ext>
                </a:extLst>
              </a:tr>
              <a:tr h="249711">
                <a:tc gridSpan="2">
                  <a:txBody>
                    <a:bodyPr/>
                    <a:lstStyle/>
                    <a:p>
                      <a:r>
                        <a:rPr lang="en-GB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lculated monomeric (</a:t>
                      </a:r>
                      <a:r>
                        <a:rPr lang="en-GB" sz="11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</a:t>
                      </a:r>
                      <a:r>
                        <a:rPr lang="en-GB" sz="1100" i="1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  <a:r>
                        <a:rPr lang="en-GB" sz="11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en-GB" sz="1100" baseline="-25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7.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7.9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9948003"/>
                  </a:ext>
                </a:extLst>
              </a:tr>
              <a:tr h="249711">
                <a:tc gridSpan="2">
                  <a:txBody>
                    <a:bodyPr/>
                    <a:lstStyle/>
                    <a:p>
                      <a:r>
                        <a:rPr lang="en-GB" sz="11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(0)</a:t>
                      </a:r>
                      <a:r>
                        <a:rPr lang="en-GB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AU) from </a:t>
                      </a:r>
                      <a:r>
                        <a:rPr lang="en-GB" sz="11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(r) / </a:t>
                      </a:r>
                      <a:r>
                        <a:rPr lang="en-GB" sz="11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rom</a:t>
                      </a:r>
                      <a:r>
                        <a:rPr lang="en-GB" sz="11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GB" sz="11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uinie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GB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3.0 ± 0.3 / 70.2 ± 0.2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91461111"/>
                  </a:ext>
                </a:extLst>
              </a:tr>
              <a:tr h="249711">
                <a:tc gridSpan="2">
                  <a:txBody>
                    <a:bodyPr/>
                    <a:lstStyle/>
                    <a:p>
                      <a:r>
                        <a:rPr lang="en-GB" sz="11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  <a:r>
                        <a:rPr lang="en-GB" sz="1100" i="1" baseline="-250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</a:t>
                      </a:r>
                      <a:r>
                        <a:rPr lang="en-GB" sz="11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nm) from </a:t>
                      </a:r>
                      <a:r>
                        <a:rPr lang="en-GB" sz="11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(r) / </a:t>
                      </a:r>
                      <a:r>
                        <a:rPr lang="en-GB" sz="11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rom</a:t>
                      </a:r>
                      <a:r>
                        <a:rPr lang="en-GB" sz="11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GB" sz="11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uinier</a:t>
                      </a:r>
                      <a:endParaRPr lang="en-GB" sz="1100" i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GB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43 ± 0.06 / 5.65 ± 0.03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36399419"/>
                  </a:ext>
                </a:extLst>
              </a:tr>
              <a:tr h="249711">
                <a:tc gridSpan="2">
                  <a:txBody>
                    <a:bodyPr/>
                    <a:lstStyle/>
                    <a:p>
                      <a:r>
                        <a:rPr lang="en-GB" sz="11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</a:t>
                      </a:r>
                      <a:r>
                        <a:rPr lang="en-GB" sz="1100" i="1" baseline="-250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x</a:t>
                      </a:r>
                      <a:r>
                        <a:rPr lang="en-GB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</a:t>
                      </a:r>
                      <a:r>
                        <a:rPr lang="en-GB" sz="11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Å</a:t>
                      </a:r>
                      <a:r>
                        <a:rPr lang="en-GB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GB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0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84022001"/>
                  </a:ext>
                </a:extLst>
              </a:tr>
              <a:tr h="249711">
                <a:tc gridSpan="2">
                  <a:txBody>
                    <a:bodyPr/>
                    <a:lstStyle/>
                    <a:p>
                      <a:r>
                        <a:rPr lang="en-GB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lecular mass (</a:t>
                      </a:r>
                      <a:r>
                        <a:rPr lang="en-GB" sz="11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</a:t>
                      </a:r>
                      <a:r>
                        <a:rPr lang="en-GB" sz="1100" i="1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  <a:r>
                        <a:rPr lang="en-GB" sz="11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 (Bayesian)</a:t>
                      </a:r>
                      <a:endParaRPr lang="en-GB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GB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8.8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78013992"/>
                  </a:ext>
                </a:extLst>
              </a:tr>
              <a:tr h="249711">
                <a:tc gridSpan="2">
                  <a:txBody>
                    <a:bodyPr/>
                    <a:lstStyle/>
                    <a:p>
                      <a:r>
                        <a:rPr lang="en-GB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SBDB database entry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GB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S6704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5217358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7857434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3075</TotalTime>
  <Words>200</Words>
  <Application>Microsoft Macintosh PowerPoint</Application>
  <PresentationFormat>A4 Paper (210x297 mm)</PresentationFormat>
  <Paragraphs>4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.X.Gomis-Rüth</dc:creator>
  <cp:lastModifiedBy>F.X.Gomis-Rüth</cp:lastModifiedBy>
  <cp:revision>406</cp:revision>
  <dcterms:created xsi:type="dcterms:W3CDTF">2024-01-16T16:15:53Z</dcterms:created>
  <dcterms:modified xsi:type="dcterms:W3CDTF">2025-06-18T09:55:31Z</dcterms:modified>
</cp:coreProperties>
</file>